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EF05B-5E41-432F-B426-953B35999C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2B2F8-5C92-4692-B233-C39E0D6C4C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B6B23-171A-4067-9EC1-BD8448B3EE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08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5360" y="286200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08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5360" y="5965560"/>
            <a:ext cx="187632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78BBD-AD87-417B-AFAD-93F8BC0D83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D7872-7B04-4E30-8861-B93FD727DC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803AE-76AB-4B16-9975-9F22414F03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4964A-F42D-4B99-B8C0-F88B23A269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3F536-ED7F-48B1-8BB6-02B1FDFD05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920"/>
            <a:ext cx="5827680" cy="764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C478B-6E36-49F3-85EC-CC8CAB54A9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F4AB1-667B-4B55-8566-38D94814AC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0640" y="596556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C439F-D913-4A2D-84F4-C216983B2A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0640" y="2862000"/>
            <a:ext cx="284364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5560"/>
            <a:ext cx="5827680" cy="28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8A042-5C2C-4F6A-97C0-BD15F9B8F6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920"/>
            <a:ext cx="5827680" cy="16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000"/>
            <a:ext cx="5827680" cy="59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440" y="9024840"/>
            <a:ext cx="142704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840"/>
            <a:ext cx="217008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840"/>
            <a:ext cx="1427040" cy="65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s-ES_tradnl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4ADFBAA6-3260-4A6F-B4BE-84EA294C36A3}" type="slidenum">
              <a:rPr b="0" lang="es-ES_tradnl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20640" y="2305080"/>
            <a:ext cx="5040360" cy="4448160"/>
          </a:xfrm>
          <a:prstGeom prst="roundRect">
            <a:avLst>
              <a:gd name="adj" fmla="val 32"/>
            </a:avLst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901800" y="2722680"/>
            <a:ext cx="4127400" cy="19825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418608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28796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3862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53852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469908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484992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316080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326088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3606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5132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36734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8228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216360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226548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23652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5160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6766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8274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115884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125892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13590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51128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16700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182232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1122480" y="2513160"/>
            <a:ext cx="806400" cy="52200"/>
          </a:xfrm>
          <a:custGeom>
            <a:avLst/>
            <a:gdLst/>
            <a:ahLst/>
            <a:rect l="l" t="t" r="r" b="b"/>
            <a:pathLst>
              <a:path w="1015" h="66">
                <a:moveTo>
                  <a:pt x="1015" y="66"/>
                </a:moveTo>
                <a:lnTo>
                  <a:pt x="1015" y="52"/>
                </a:lnTo>
                <a:lnTo>
                  <a:pt x="1015" y="41"/>
                </a:lnTo>
                <a:lnTo>
                  <a:pt x="1015" y="34"/>
                </a:lnTo>
                <a:lnTo>
                  <a:pt x="1015" y="30"/>
                </a:lnTo>
                <a:lnTo>
                  <a:pt x="1015" y="24"/>
                </a:lnTo>
                <a:lnTo>
                  <a:pt x="1015" y="20"/>
                </a:lnTo>
                <a:lnTo>
                  <a:pt x="1015" y="16"/>
                </a:lnTo>
                <a:lnTo>
                  <a:pt x="1015" y="11"/>
                </a:lnTo>
                <a:lnTo>
                  <a:pt x="1015" y="9"/>
                </a:lnTo>
                <a:lnTo>
                  <a:pt x="1015" y="6"/>
                </a:lnTo>
                <a:lnTo>
                  <a:pt x="1015" y="3"/>
                </a:lnTo>
                <a:lnTo>
                  <a:pt x="1015" y="2"/>
                </a:lnTo>
                <a:lnTo>
                  <a:pt x="1015" y="0"/>
                </a:lnTo>
                <a:lnTo>
                  <a:pt x="1015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4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2128680" y="2513160"/>
            <a:ext cx="804960" cy="52200"/>
          </a:xfrm>
          <a:custGeom>
            <a:avLst/>
            <a:gdLst/>
            <a:ahLst/>
            <a:rect l="l" t="t" r="r" b="b"/>
            <a:pathLst>
              <a:path w="1014" h="66">
                <a:moveTo>
                  <a:pt x="1014" y="66"/>
                </a:moveTo>
                <a:lnTo>
                  <a:pt x="1014" y="52"/>
                </a:lnTo>
                <a:lnTo>
                  <a:pt x="1014" y="41"/>
                </a:lnTo>
                <a:lnTo>
                  <a:pt x="1014" y="34"/>
                </a:lnTo>
                <a:lnTo>
                  <a:pt x="1014" y="30"/>
                </a:lnTo>
                <a:lnTo>
                  <a:pt x="1014" y="24"/>
                </a:lnTo>
                <a:lnTo>
                  <a:pt x="1014" y="20"/>
                </a:lnTo>
                <a:lnTo>
                  <a:pt x="1014" y="16"/>
                </a:lnTo>
                <a:lnTo>
                  <a:pt x="1014" y="11"/>
                </a:lnTo>
                <a:lnTo>
                  <a:pt x="1014" y="9"/>
                </a:lnTo>
                <a:lnTo>
                  <a:pt x="1014" y="6"/>
                </a:lnTo>
                <a:lnTo>
                  <a:pt x="1014" y="3"/>
                </a:lnTo>
                <a:lnTo>
                  <a:pt x="1014" y="2"/>
                </a:lnTo>
                <a:lnTo>
                  <a:pt x="1014" y="0"/>
                </a:lnTo>
                <a:lnTo>
                  <a:pt x="1014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4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3124080" y="2513160"/>
            <a:ext cx="804960" cy="52200"/>
          </a:xfrm>
          <a:custGeom>
            <a:avLst/>
            <a:gdLst/>
            <a:ahLst/>
            <a:rect l="l" t="t" r="r" b="b"/>
            <a:pathLst>
              <a:path w="1014" h="66">
                <a:moveTo>
                  <a:pt x="1014" y="66"/>
                </a:moveTo>
                <a:lnTo>
                  <a:pt x="1014" y="52"/>
                </a:lnTo>
                <a:lnTo>
                  <a:pt x="1014" y="41"/>
                </a:lnTo>
                <a:lnTo>
                  <a:pt x="1014" y="34"/>
                </a:lnTo>
                <a:lnTo>
                  <a:pt x="1014" y="30"/>
                </a:lnTo>
                <a:lnTo>
                  <a:pt x="1014" y="24"/>
                </a:lnTo>
                <a:lnTo>
                  <a:pt x="1014" y="20"/>
                </a:lnTo>
                <a:lnTo>
                  <a:pt x="1014" y="16"/>
                </a:lnTo>
                <a:lnTo>
                  <a:pt x="1014" y="11"/>
                </a:lnTo>
                <a:lnTo>
                  <a:pt x="1014" y="9"/>
                </a:lnTo>
                <a:lnTo>
                  <a:pt x="1014" y="6"/>
                </a:lnTo>
                <a:lnTo>
                  <a:pt x="1014" y="3"/>
                </a:lnTo>
                <a:lnTo>
                  <a:pt x="1014" y="2"/>
                </a:lnTo>
                <a:lnTo>
                  <a:pt x="1014" y="0"/>
                </a:lnTo>
                <a:lnTo>
                  <a:pt x="1014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4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162320" y="2513160"/>
            <a:ext cx="804960" cy="52200"/>
          </a:xfrm>
          <a:custGeom>
            <a:avLst/>
            <a:gdLst/>
            <a:ahLst/>
            <a:rect l="l" t="t" r="r" b="b"/>
            <a:pathLst>
              <a:path w="1014" h="66">
                <a:moveTo>
                  <a:pt x="1014" y="66"/>
                </a:moveTo>
                <a:lnTo>
                  <a:pt x="1014" y="52"/>
                </a:lnTo>
                <a:lnTo>
                  <a:pt x="1014" y="41"/>
                </a:lnTo>
                <a:lnTo>
                  <a:pt x="1014" y="35"/>
                </a:lnTo>
                <a:lnTo>
                  <a:pt x="1014" y="30"/>
                </a:lnTo>
                <a:lnTo>
                  <a:pt x="1014" y="24"/>
                </a:lnTo>
                <a:lnTo>
                  <a:pt x="1014" y="20"/>
                </a:lnTo>
                <a:lnTo>
                  <a:pt x="1014" y="16"/>
                </a:lnTo>
                <a:lnTo>
                  <a:pt x="1014" y="11"/>
                </a:lnTo>
                <a:lnTo>
                  <a:pt x="1014" y="9"/>
                </a:lnTo>
                <a:lnTo>
                  <a:pt x="1014" y="6"/>
                </a:lnTo>
                <a:lnTo>
                  <a:pt x="1014" y="3"/>
                </a:lnTo>
                <a:lnTo>
                  <a:pt x="1014" y="2"/>
                </a:lnTo>
                <a:lnTo>
                  <a:pt x="1014" y="0"/>
                </a:lnTo>
                <a:lnTo>
                  <a:pt x="1014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5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1417680" y="2352600"/>
            <a:ext cx="241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DSN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2324160" y="2352600"/>
            <a:ext cx="433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DSN 1/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330720" y="2343240"/>
            <a:ext cx="433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DSN 1/4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305600" y="2343240"/>
            <a:ext cx="564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5010120" y="257328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CR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5242680" y="2573280"/>
            <a:ext cx="23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ycl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7" name="" descr=""/>
          <p:cNvPicPr/>
          <p:nvPr/>
        </p:nvPicPr>
        <p:blipFill>
          <a:blip r:embed="rId2"/>
          <a:stretch/>
        </p:blipFill>
        <p:spPr>
          <a:xfrm>
            <a:off x="901800" y="2722680"/>
            <a:ext cx="4127400" cy="198252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418608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28796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3862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453852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69908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484992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16080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326088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33606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35132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36734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38228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216360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226548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23652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25160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26766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28274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115884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1258920" y="25858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135900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151128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167004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1822320" y="2585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1122480" y="2513160"/>
            <a:ext cx="806400" cy="52200"/>
          </a:xfrm>
          <a:custGeom>
            <a:avLst/>
            <a:gdLst/>
            <a:ahLst/>
            <a:rect l="l" t="t" r="r" b="b"/>
            <a:pathLst>
              <a:path w="1015" h="66">
                <a:moveTo>
                  <a:pt x="1015" y="66"/>
                </a:moveTo>
                <a:lnTo>
                  <a:pt x="1015" y="52"/>
                </a:lnTo>
                <a:lnTo>
                  <a:pt x="1015" y="41"/>
                </a:lnTo>
                <a:lnTo>
                  <a:pt x="1015" y="34"/>
                </a:lnTo>
                <a:lnTo>
                  <a:pt x="1015" y="30"/>
                </a:lnTo>
                <a:lnTo>
                  <a:pt x="1015" y="24"/>
                </a:lnTo>
                <a:lnTo>
                  <a:pt x="1015" y="20"/>
                </a:lnTo>
                <a:lnTo>
                  <a:pt x="1015" y="16"/>
                </a:lnTo>
                <a:lnTo>
                  <a:pt x="1015" y="11"/>
                </a:lnTo>
                <a:lnTo>
                  <a:pt x="1015" y="9"/>
                </a:lnTo>
                <a:lnTo>
                  <a:pt x="1015" y="6"/>
                </a:lnTo>
                <a:lnTo>
                  <a:pt x="1015" y="3"/>
                </a:lnTo>
                <a:lnTo>
                  <a:pt x="1015" y="2"/>
                </a:lnTo>
                <a:lnTo>
                  <a:pt x="1015" y="0"/>
                </a:lnTo>
                <a:lnTo>
                  <a:pt x="1015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4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2128680" y="2513160"/>
            <a:ext cx="804960" cy="52200"/>
          </a:xfrm>
          <a:custGeom>
            <a:avLst/>
            <a:gdLst/>
            <a:ahLst/>
            <a:rect l="l" t="t" r="r" b="b"/>
            <a:pathLst>
              <a:path w="1014" h="66">
                <a:moveTo>
                  <a:pt x="1014" y="66"/>
                </a:moveTo>
                <a:lnTo>
                  <a:pt x="1014" y="52"/>
                </a:lnTo>
                <a:lnTo>
                  <a:pt x="1014" y="41"/>
                </a:lnTo>
                <a:lnTo>
                  <a:pt x="1014" y="34"/>
                </a:lnTo>
                <a:lnTo>
                  <a:pt x="1014" y="30"/>
                </a:lnTo>
                <a:lnTo>
                  <a:pt x="1014" y="24"/>
                </a:lnTo>
                <a:lnTo>
                  <a:pt x="1014" y="20"/>
                </a:lnTo>
                <a:lnTo>
                  <a:pt x="1014" y="16"/>
                </a:lnTo>
                <a:lnTo>
                  <a:pt x="1014" y="11"/>
                </a:lnTo>
                <a:lnTo>
                  <a:pt x="1014" y="9"/>
                </a:lnTo>
                <a:lnTo>
                  <a:pt x="1014" y="6"/>
                </a:lnTo>
                <a:lnTo>
                  <a:pt x="1014" y="3"/>
                </a:lnTo>
                <a:lnTo>
                  <a:pt x="1014" y="2"/>
                </a:lnTo>
                <a:lnTo>
                  <a:pt x="1014" y="0"/>
                </a:lnTo>
                <a:lnTo>
                  <a:pt x="1014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4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3124080" y="2513160"/>
            <a:ext cx="804960" cy="52200"/>
          </a:xfrm>
          <a:custGeom>
            <a:avLst/>
            <a:gdLst/>
            <a:ahLst/>
            <a:rect l="l" t="t" r="r" b="b"/>
            <a:pathLst>
              <a:path w="1014" h="66">
                <a:moveTo>
                  <a:pt x="1014" y="66"/>
                </a:moveTo>
                <a:lnTo>
                  <a:pt x="1014" y="52"/>
                </a:lnTo>
                <a:lnTo>
                  <a:pt x="1014" y="41"/>
                </a:lnTo>
                <a:lnTo>
                  <a:pt x="1014" y="34"/>
                </a:lnTo>
                <a:lnTo>
                  <a:pt x="1014" y="30"/>
                </a:lnTo>
                <a:lnTo>
                  <a:pt x="1014" y="24"/>
                </a:lnTo>
                <a:lnTo>
                  <a:pt x="1014" y="20"/>
                </a:lnTo>
                <a:lnTo>
                  <a:pt x="1014" y="16"/>
                </a:lnTo>
                <a:lnTo>
                  <a:pt x="1014" y="11"/>
                </a:lnTo>
                <a:lnTo>
                  <a:pt x="1014" y="9"/>
                </a:lnTo>
                <a:lnTo>
                  <a:pt x="1014" y="6"/>
                </a:lnTo>
                <a:lnTo>
                  <a:pt x="1014" y="3"/>
                </a:lnTo>
                <a:lnTo>
                  <a:pt x="1014" y="2"/>
                </a:lnTo>
                <a:lnTo>
                  <a:pt x="1014" y="0"/>
                </a:lnTo>
                <a:lnTo>
                  <a:pt x="1014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4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4162320" y="2513160"/>
            <a:ext cx="804960" cy="52200"/>
          </a:xfrm>
          <a:custGeom>
            <a:avLst/>
            <a:gdLst/>
            <a:ahLst/>
            <a:rect l="l" t="t" r="r" b="b"/>
            <a:pathLst>
              <a:path w="1014" h="66">
                <a:moveTo>
                  <a:pt x="1014" y="66"/>
                </a:moveTo>
                <a:lnTo>
                  <a:pt x="1014" y="52"/>
                </a:lnTo>
                <a:lnTo>
                  <a:pt x="1014" y="41"/>
                </a:lnTo>
                <a:lnTo>
                  <a:pt x="1014" y="35"/>
                </a:lnTo>
                <a:lnTo>
                  <a:pt x="1014" y="30"/>
                </a:lnTo>
                <a:lnTo>
                  <a:pt x="1014" y="24"/>
                </a:lnTo>
                <a:lnTo>
                  <a:pt x="1014" y="20"/>
                </a:lnTo>
                <a:lnTo>
                  <a:pt x="1014" y="16"/>
                </a:lnTo>
                <a:lnTo>
                  <a:pt x="1014" y="11"/>
                </a:lnTo>
                <a:lnTo>
                  <a:pt x="1014" y="9"/>
                </a:lnTo>
                <a:lnTo>
                  <a:pt x="1014" y="6"/>
                </a:lnTo>
                <a:lnTo>
                  <a:pt x="1014" y="3"/>
                </a:lnTo>
                <a:lnTo>
                  <a:pt x="1014" y="2"/>
                </a:lnTo>
                <a:lnTo>
                  <a:pt x="1014" y="0"/>
                </a:lnTo>
                <a:lnTo>
                  <a:pt x="1014" y="0"/>
                </a:lnTo>
                <a:lnTo>
                  <a:pt x="0" y="0"/>
                </a:lnTo>
                <a:lnTo>
                  <a:pt x="0" y="0"/>
                </a:lnTo>
                <a:lnTo>
                  <a:pt x="0" y="2"/>
                </a:lnTo>
                <a:lnTo>
                  <a:pt x="0" y="3"/>
                </a:lnTo>
                <a:lnTo>
                  <a:pt x="0" y="6"/>
                </a:lnTo>
                <a:lnTo>
                  <a:pt x="0" y="9"/>
                </a:lnTo>
                <a:lnTo>
                  <a:pt x="0" y="11"/>
                </a:lnTo>
                <a:lnTo>
                  <a:pt x="0" y="16"/>
                </a:lnTo>
                <a:lnTo>
                  <a:pt x="0" y="20"/>
                </a:lnTo>
                <a:lnTo>
                  <a:pt x="0" y="24"/>
                </a:lnTo>
                <a:lnTo>
                  <a:pt x="0" y="30"/>
                </a:lnTo>
                <a:lnTo>
                  <a:pt x="0" y="35"/>
                </a:lnTo>
                <a:lnTo>
                  <a:pt x="0" y="41"/>
                </a:lnTo>
                <a:lnTo>
                  <a:pt x="0" y="52"/>
                </a:lnTo>
                <a:lnTo>
                  <a:pt x="0" y="66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400" bIns="5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1417680" y="2352600"/>
            <a:ext cx="241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DSN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324160" y="2352600"/>
            <a:ext cx="433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DSN 1/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3330720" y="2343240"/>
            <a:ext cx="433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DSN 1/4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4305600" y="2343240"/>
            <a:ext cx="5644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5010120" y="2573280"/>
            <a:ext cx="244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CR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5242680" y="2573280"/>
            <a:ext cx="235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ycl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685800" y="2660760"/>
            <a:ext cx="1195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13" name=""/>
          <p:cNvGrpSpPr/>
          <p:nvPr/>
        </p:nvGrpSpPr>
        <p:grpSpPr>
          <a:xfrm>
            <a:off x="907560" y="4754520"/>
            <a:ext cx="1090800" cy="1996920"/>
            <a:chOff x="907560" y="4754520"/>
            <a:chExt cx="1090800" cy="1996920"/>
          </a:xfrm>
        </p:grpSpPr>
        <p:pic>
          <p:nvPicPr>
            <p:cNvPr id="114" name="" descr=""/>
            <p:cNvPicPr/>
            <p:nvPr/>
          </p:nvPicPr>
          <p:blipFill>
            <a:blip r:embed="rId3"/>
            <a:stretch/>
          </p:blipFill>
          <p:spPr>
            <a:xfrm>
              <a:off x="1126800" y="4817880"/>
              <a:ext cx="871560" cy="1933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" name=""/>
            <p:cNvSpPr/>
            <p:nvPr/>
          </p:nvSpPr>
          <p:spPr>
            <a:xfrm>
              <a:off x="907560" y="4754520"/>
              <a:ext cx="1195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3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16" name=""/>
          <p:cNvGrpSpPr/>
          <p:nvPr/>
        </p:nvGrpSpPr>
        <p:grpSpPr>
          <a:xfrm>
            <a:off x="2342880" y="4753080"/>
            <a:ext cx="1198440" cy="1996560"/>
            <a:chOff x="2342880" y="4753080"/>
            <a:chExt cx="1198440" cy="1996560"/>
          </a:xfrm>
        </p:grpSpPr>
        <p:pic>
          <p:nvPicPr>
            <p:cNvPr id="117" name="" descr=""/>
            <p:cNvPicPr/>
            <p:nvPr/>
          </p:nvPicPr>
          <p:blipFill>
            <a:blip r:embed="rId4"/>
            <a:stretch/>
          </p:blipFill>
          <p:spPr>
            <a:xfrm>
              <a:off x="2520720" y="4811400"/>
              <a:ext cx="1020600" cy="193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8" name=""/>
            <p:cNvSpPr/>
            <p:nvPr/>
          </p:nvSpPr>
          <p:spPr>
            <a:xfrm>
              <a:off x="2342880" y="4753080"/>
              <a:ext cx="1195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3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19" name=""/>
          <p:cNvGrpSpPr/>
          <p:nvPr/>
        </p:nvGrpSpPr>
        <p:grpSpPr>
          <a:xfrm>
            <a:off x="3885840" y="4753080"/>
            <a:ext cx="1035000" cy="1996560"/>
            <a:chOff x="3885840" y="4753080"/>
            <a:chExt cx="1035000" cy="1996560"/>
          </a:xfrm>
        </p:grpSpPr>
        <p:pic>
          <p:nvPicPr>
            <p:cNvPr id="120" name="" descr=""/>
            <p:cNvPicPr/>
            <p:nvPr/>
          </p:nvPicPr>
          <p:blipFill>
            <a:blip r:embed="rId5"/>
            <a:stretch/>
          </p:blipFill>
          <p:spPr>
            <a:xfrm>
              <a:off x="4076280" y="4816080"/>
              <a:ext cx="844560" cy="1933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"/>
            <p:cNvSpPr/>
            <p:nvPr/>
          </p:nvSpPr>
          <p:spPr>
            <a:xfrm>
              <a:off x="3885840" y="4753080"/>
              <a:ext cx="1195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3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22" name=""/>
          <p:cNvSpPr/>
          <p:nvPr/>
        </p:nvSpPr>
        <p:spPr>
          <a:xfrm>
            <a:off x="474120" y="561960"/>
            <a:ext cx="566244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2" marL="914400">
              <a:lnSpc>
                <a:spcPct val="100000"/>
              </a:lnSpc>
              <a:tabLst>
                <a:tab algn="l" pos="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dditional file 5</a:t>
            </a:r>
            <a:r>
              <a:rPr b="1" lang="en-GB" sz="10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Evaluation of the efficiency of normalization of cDNA libraries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,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Gel electrophoresis analysis of 5 µl aliquots from the first amplification of the normalized cDN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taken at different PCR cycles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,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Gel electrophoresis analysis of the normalized cDNA utilized in the construction of the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ormalized cDNA library RVDevelopN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Gel electrophoresis analysis of a non-normalized cDNA population (left) and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 normalized cDNA population (right) from the same RNA sample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D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Virtual northern of the cDNA smear blotted and hybridized with the highly abundant clone C32009H03.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pereza</cp:lastModifiedBy>
  <dcterms:modified xsi:type="dcterms:W3CDTF">2009-09-08T07:15:01Z</dcterms:modified>
  <cp:revision>3</cp:revision>
  <dc:subject/>
  <dc:title>PowerPoint Presentation</dc:title>
</cp:coreProperties>
</file>